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7" r:id="rId2"/>
    <p:sldId id="262" r:id="rId3"/>
    <p:sldId id="260" r:id="rId4"/>
  </p:sldIdLst>
  <p:sldSz cx="91440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6010" autoAdjust="0"/>
  </p:normalViewPr>
  <p:slideViewPr>
    <p:cSldViewPr snapToGrid="0">
      <p:cViewPr varScale="1">
        <p:scale>
          <a:sx n="79" d="100"/>
          <a:sy n="79" d="100"/>
        </p:scale>
        <p:origin x="258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068789-712A-458A-9C48-ABF1B407EA6F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25650" y="1143000"/>
            <a:ext cx="2806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5C5E2F-C57E-486B-AAC2-3689411BE3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7323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cale 50 um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55C94C-6868-4E29-B7E6-C1A137BE28D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4915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646133"/>
            <a:ext cx="7772400" cy="350181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5282989"/>
            <a:ext cx="6858000" cy="2428451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9853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057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535517"/>
            <a:ext cx="1971675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535517"/>
            <a:ext cx="5800725" cy="8524029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7858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443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507618"/>
            <a:ext cx="7886700" cy="418401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731215"/>
            <a:ext cx="7886700" cy="220027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333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677584"/>
            <a:ext cx="3886200" cy="63819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677584"/>
            <a:ext cx="3886200" cy="63819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699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35519"/>
            <a:ext cx="7886700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465706"/>
            <a:ext cx="3868340" cy="120840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674110"/>
            <a:ext cx="3868340" cy="54040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465706"/>
            <a:ext cx="3887391" cy="120840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674110"/>
            <a:ext cx="3887391" cy="54040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6188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1207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285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70560"/>
            <a:ext cx="2949178" cy="23469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448226"/>
            <a:ext cx="4629150" cy="714798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017520"/>
            <a:ext cx="2949178" cy="559032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070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70560"/>
            <a:ext cx="2949178" cy="23469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448226"/>
            <a:ext cx="4629150" cy="7147983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017520"/>
            <a:ext cx="2949178" cy="5590329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0158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535519"/>
            <a:ext cx="788670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2677584"/>
            <a:ext cx="788670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9322649"/>
            <a:ext cx="205740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D00FA-7267-49F4-8F12-BA0973F196F5}" type="datetimeFigureOut">
              <a:rPr lang="en-US" smtClean="0"/>
              <a:t>8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9322649"/>
            <a:ext cx="308610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9322649"/>
            <a:ext cx="205740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100C72-71C7-4EE0-B2CA-D40E456C8B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253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10" Type="http://schemas.openxmlformats.org/officeDocument/2006/relationships/image" Target="../media/image19.tiff"/><Relationship Id="rId4" Type="http://schemas.openxmlformats.org/officeDocument/2006/relationships/image" Target="../media/image13.tiff"/><Relationship Id="rId9" Type="http://schemas.openxmlformats.org/officeDocument/2006/relationships/image" Target="../media/image1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f"/><Relationship Id="rId3" Type="http://schemas.openxmlformats.org/officeDocument/2006/relationships/image" Target="../media/image21.tiff"/><Relationship Id="rId7" Type="http://schemas.openxmlformats.org/officeDocument/2006/relationships/image" Target="../media/image25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f"/><Relationship Id="rId9" Type="http://schemas.openxmlformats.org/officeDocument/2006/relationships/image" Target="../media/image2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486146" y="911195"/>
            <a:ext cx="2198487" cy="34406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36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rce </a:t>
            </a:r>
            <a:r>
              <a:rPr lang="en-US" sz="1636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ta Figure 1A</a:t>
            </a:r>
            <a:endParaRPr lang="en-US" sz="163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4" name="Group 33"/>
          <p:cNvGrpSpPr/>
          <p:nvPr/>
        </p:nvGrpSpPr>
        <p:grpSpPr>
          <a:xfrm>
            <a:off x="413369" y="1566319"/>
            <a:ext cx="3423485" cy="4347257"/>
            <a:chOff x="923568" y="2207367"/>
            <a:chExt cx="3423485" cy="4347257"/>
          </a:xfrm>
        </p:grpSpPr>
        <p:pic>
          <p:nvPicPr>
            <p:cNvPr id="63" name="Picture 62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47" t="89" r="20533" b="78349"/>
            <a:stretch/>
          </p:blipFill>
          <p:spPr>
            <a:xfrm>
              <a:off x="1449239" y="2207367"/>
              <a:ext cx="1834551" cy="664923"/>
            </a:xfrm>
            <a:prstGeom prst="rect">
              <a:avLst/>
            </a:prstGeom>
            <a:ln w="3175">
              <a:noFill/>
            </a:ln>
          </p:spPr>
        </p:pic>
        <p:pic>
          <p:nvPicPr>
            <p:cNvPr id="83" name="Picture 82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37" t="33714" r="23112" b="23007"/>
            <a:stretch/>
          </p:blipFill>
          <p:spPr>
            <a:xfrm>
              <a:off x="1449239" y="3838470"/>
              <a:ext cx="1828800" cy="1075173"/>
            </a:xfrm>
            <a:prstGeom prst="rect">
              <a:avLst/>
            </a:prstGeom>
            <a:ln w="3175">
              <a:noFill/>
            </a:ln>
          </p:spPr>
        </p:pic>
        <p:pic>
          <p:nvPicPr>
            <p:cNvPr id="84" name="Picture 83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933" t="19203" r="20181" b="48275"/>
            <a:stretch/>
          </p:blipFill>
          <p:spPr>
            <a:xfrm>
              <a:off x="1449239" y="2987907"/>
              <a:ext cx="1805798" cy="622998"/>
            </a:xfrm>
            <a:prstGeom prst="rect">
              <a:avLst/>
            </a:prstGeom>
            <a:ln w="3175">
              <a:noFill/>
            </a:ln>
          </p:spPr>
        </p:pic>
        <p:sp>
          <p:nvSpPr>
            <p:cNvPr id="88" name="TextBox 87"/>
            <p:cNvSpPr txBox="1"/>
            <p:nvPr/>
          </p:nvSpPr>
          <p:spPr>
            <a:xfrm>
              <a:off x="3273231" y="2501445"/>
              <a:ext cx="704039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IRE1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3307414" y="3303498"/>
              <a:ext cx="558166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E1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315960" y="3849497"/>
              <a:ext cx="65755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XBP1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2" name="Picture 121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09" t="3928" r="9967" b="21566"/>
            <a:stretch/>
          </p:blipFill>
          <p:spPr>
            <a:xfrm>
              <a:off x="1461332" y="5009090"/>
              <a:ext cx="1858918" cy="1545534"/>
            </a:xfrm>
            <a:prstGeom prst="rect">
              <a:avLst/>
            </a:prstGeom>
            <a:ln w="3175">
              <a:noFill/>
            </a:ln>
          </p:spPr>
        </p:pic>
        <p:sp>
          <p:nvSpPr>
            <p:cNvPr id="127" name="TextBox 126"/>
            <p:cNvSpPr txBox="1"/>
            <p:nvPr/>
          </p:nvSpPr>
          <p:spPr>
            <a:xfrm>
              <a:off x="3441036" y="5425007"/>
              <a:ext cx="906017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nceau</a:t>
              </a:r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7" name="Straight Connector 136"/>
            <p:cNvCxnSpPr/>
            <p:nvPr/>
          </p:nvCxnSpPr>
          <p:spPr>
            <a:xfrm flipV="1">
              <a:off x="1291949" y="2698837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Box 137"/>
            <p:cNvSpPr txBox="1"/>
            <p:nvPr/>
          </p:nvSpPr>
          <p:spPr>
            <a:xfrm>
              <a:off x="923568" y="2566882"/>
              <a:ext cx="420949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9" name="Straight Connector 138"/>
            <p:cNvCxnSpPr/>
            <p:nvPr/>
          </p:nvCxnSpPr>
          <p:spPr>
            <a:xfrm flipV="1">
              <a:off x="1291949" y="3420579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/>
            <p:cNvSpPr txBox="1"/>
            <p:nvPr/>
          </p:nvSpPr>
          <p:spPr>
            <a:xfrm>
              <a:off x="923568" y="3288624"/>
              <a:ext cx="420949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1" name="Straight Connector 140"/>
            <p:cNvCxnSpPr/>
            <p:nvPr/>
          </p:nvCxnSpPr>
          <p:spPr>
            <a:xfrm flipV="1">
              <a:off x="1291949" y="4240088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141"/>
            <p:cNvSpPr txBox="1"/>
            <p:nvPr/>
          </p:nvSpPr>
          <p:spPr>
            <a:xfrm>
              <a:off x="996345" y="4108133"/>
              <a:ext cx="34817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4217137" y="911195"/>
            <a:ext cx="3234049" cy="6005534"/>
            <a:chOff x="303505" y="1191331"/>
            <a:chExt cx="3234049" cy="6005534"/>
          </a:xfrm>
        </p:grpSpPr>
        <p:sp>
          <p:nvSpPr>
            <p:cNvPr id="19" name="TextBox 18"/>
            <p:cNvSpPr txBox="1"/>
            <p:nvPr/>
          </p:nvSpPr>
          <p:spPr>
            <a:xfrm>
              <a:off x="2660391" y="3882712"/>
              <a:ext cx="63991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E1 </a:t>
              </a:r>
              <a:endPara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660391" y="4783201"/>
              <a:ext cx="877163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 </a:t>
              </a:r>
              <a:endPara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660391" y="5545293"/>
              <a:ext cx="63991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E1 </a:t>
              </a:r>
              <a:endPara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660391" y="6386666"/>
              <a:ext cx="877163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 </a:t>
              </a:r>
              <a:endPara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03505" y="1191331"/>
              <a:ext cx="2185663" cy="34406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636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urce data Figure 1B</a:t>
              </a:r>
              <a:endParaRPr lang="en-US" sz="1636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660391" y="2009327"/>
              <a:ext cx="639919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E1 </a:t>
              </a:r>
              <a:endPara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660391" y="3064346"/>
              <a:ext cx="877163" cy="307777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 </a:t>
              </a:r>
              <a:endPara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Straight Connector 26"/>
            <p:cNvCxnSpPr/>
            <p:nvPr/>
          </p:nvCxnSpPr>
          <p:spPr>
            <a:xfrm flipV="1">
              <a:off x="1128048" y="2250263"/>
              <a:ext cx="182880" cy="1447"/>
            </a:xfrm>
            <a:prstGeom prst="line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/>
          </p:nvCxnSpPr>
          <p:spPr>
            <a:xfrm flipV="1">
              <a:off x="1128048" y="3141803"/>
              <a:ext cx="182880" cy="1447"/>
            </a:xfrm>
            <a:prstGeom prst="line">
              <a:avLst/>
            </a:prstGeom>
            <a:ln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 flipV="1">
              <a:off x="1128048" y="2138118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/>
            <p:cNvSpPr txBox="1"/>
            <p:nvPr/>
          </p:nvSpPr>
          <p:spPr>
            <a:xfrm>
              <a:off x="753915" y="2006163"/>
              <a:ext cx="420949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Straight Connector 30"/>
            <p:cNvCxnSpPr/>
            <p:nvPr/>
          </p:nvCxnSpPr>
          <p:spPr>
            <a:xfrm flipV="1">
              <a:off x="1128048" y="3958292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753915" y="3826337"/>
              <a:ext cx="420949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Straight Connector 32"/>
            <p:cNvCxnSpPr/>
            <p:nvPr/>
          </p:nvCxnSpPr>
          <p:spPr>
            <a:xfrm flipV="1">
              <a:off x="1128048" y="5715205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753915" y="5583250"/>
              <a:ext cx="420949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6" name="Straight Connector 35"/>
            <p:cNvCxnSpPr/>
            <p:nvPr/>
          </p:nvCxnSpPr>
          <p:spPr>
            <a:xfrm flipV="1">
              <a:off x="1128048" y="3158911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826692" y="3026956"/>
              <a:ext cx="34817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8" name="Straight Connector 37"/>
            <p:cNvCxnSpPr/>
            <p:nvPr/>
          </p:nvCxnSpPr>
          <p:spPr>
            <a:xfrm flipV="1">
              <a:off x="1128048" y="4898572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826692" y="4766617"/>
              <a:ext cx="34817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0" name="Straight Connector 39"/>
            <p:cNvCxnSpPr/>
            <p:nvPr/>
          </p:nvCxnSpPr>
          <p:spPr>
            <a:xfrm flipV="1">
              <a:off x="1128048" y="6563470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826692" y="6431515"/>
              <a:ext cx="34817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2" name="Picture 41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96" t="62396" r="55060" b="6653"/>
            <a:stretch/>
          </p:blipFill>
          <p:spPr>
            <a:xfrm>
              <a:off x="1266436" y="1929283"/>
              <a:ext cx="1436914" cy="803868"/>
            </a:xfrm>
            <a:prstGeom prst="rect">
              <a:avLst/>
            </a:prstGeom>
            <a:ln w="3175">
              <a:noFill/>
            </a:ln>
          </p:spPr>
        </p:pic>
        <p:pic>
          <p:nvPicPr>
            <p:cNvPr id="43" name="Picture 42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67" t="57087" r="51744" b="18943"/>
            <a:stretch/>
          </p:blipFill>
          <p:spPr>
            <a:xfrm>
              <a:off x="1266436" y="2793441"/>
              <a:ext cx="1366505" cy="663192"/>
            </a:xfrm>
            <a:prstGeom prst="rect">
              <a:avLst/>
            </a:prstGeom>
            <a:ln w="3175">
              <a:noFill/>
            </a:ln>
          </p:spPr>
        </p:pic>
        <p:pic>
          <p:nvPicPr>
            <p:cNvPr id="44" name="Picture 43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674" t="25423" r="24024" b="49568"/>
            <a:stretch/>
          </p:blipFill>
          <p:spPr>
            <a:xfrm flipH="1">
              <a:off x="1266436" y="3539490"/>
              <a:ext cx="1354543" cy="845820"/>
            </a:xfrm>
            <a:prstGeom prst="rect">
              <a:avLst/>
            </a:prstGeom>
            <a:ln w="3175">
              <a:noFill/>
            </a:ln>
          </p:spPr>
        </p:pic>
        <p:pic>
          <p:nvPicPr>
            <p:cNvPr id="45" name="Picture 44"/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984" t="25118" r="26284" b="45334"/>
            <a:stretch/>
          </p:blipFill>
          <p:spPr>
            <a:xfrm flipH="1">
              <a:off x="1266436" y="4411980"/>
              <a:ext cx="1362163" cy="986790"/>
            </a:xfrm>
            <a:prstGeom prst="rect">
              <a:avLst/>
            </a:prstGeom>
            <a:ln w="3175">
              <a:noFill/>
            </a:ln>
          </p:spPr>
        </p:pic>
        <p:pic>
          <p:nvPicPr>
            <p:cNvPr id="46" name="Picture 45"/>
            <p:cNvPicPr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623" t="2845" r="26418" b="72623"/>
            <a:stretch/>
          </p:blipFill>
          <p:spPr>
            <a:xfrm>
              <a:off x="1266436" y="6185646"/>
              <a:ext cx="1371600" cy="1011219"/>
            </a:xfrm>
            <a:prstGeom prst="rect">
              <a:avLst/>
            </a:prstGeom>
            <a:ln w="3175">
              <a:noFill/>
            </a:ln>
          </p:spPr>
        </p:pic>
        <p:pic>
          <p:nvPicPr>
            <p:cNvPr id="47" name="Picture 46"/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328" t="3611" r="21160" b="76752"/>
            <a:stretch/>
          </p:blipFill>
          <p:spPr>
            <a:xfrm>
              <a:off x="1266436" y="5443368"/>
              <a:ext cx="1371600" cy="634701"/>
            </a:xfrm>
            <a:prstGeom prst="rect">
              <a:avLst/>
            </a:prstGeom>
            <a:ln w="3175">
              <a:noFill/>
            </a:ln>
          </p:spPr>
        </p:pic>
      </p:grpSp>
      <p:sp>
        <p:nvSpPr>
          <p:cNvPr id="2" name="TextBox 1"/>
          <p:cNvSpPr txBox="1"/>
          <p:nvPr/>
        </p:nvSpPr>
        <p:spPr>
          <a:xfrm>
            <a:off x="3137258" y="224630"/>
            <a:ext cx="2450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cropped Gel Images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57278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7669" y="926591"/>
            <a:ext cx="3927949" cy="707619"/>
            <a:chOff x="521237" y="2365247"/>
            <a:chExt cx="3927949" cy="707619"/>
          </a:xfrm>
        </p:grpSpPr>
        <p:cxnSp>
          <p:nvCxnSpPr>
            <p:cNvPr id="26" name="Straight Connector 25"/>
            <p:cNvCxnSpPr/>
            <p:nvPr/>
          </p:nvCxnSpPr>
          <p:spPr>
            <a:xfrm flipV="1">
              <a:off x="927761" y="2681993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" name="Picture 6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05" t="34399" r="17938" b="36786"/>
            <a:stretch/>
          </p:blipFill>
          <p:spPr>
            <a:xfrm>
              <a:off x="1050387" y="2365247"/>
              <a:ext cx="2638821" cy="707619"/>
            </a:xfrm>
            <a:prstGeom prst="rect">
              <a:avLst/>
            </a:prstGeom>
            <a:ln w="9525">
              <a:noFill/>
            </a:ln>
          </p:spPr>
        </p:pic>
        <p:sp>
          <p:nvSpPr>
            <p:cNvPr id="21" name="TextBox 20"/>
            <p:cNvSpPr txBox="1"/>
            <p:nvPr/>
          </p:nvSpPr>
          <p:spPr>
            <a:xfrm>
              <a:off x="3655379" y="2414029"/>
              <a:ext cx="7938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MyHC</a:t>
              </a:r>
              <a:endPara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21237" y="2537508"/>
              <a:ext cx="429926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49423" y="1647271"/>
            <a:ext cx="3847216" cy="1240387"/>
            <a:chOff x="602991" y="3085927"/>
            <a:chExt cx="3847216" cy="1240387"/>
          </a:xfrm>
        </p:grpSpPr>
        <p:cxnSp>
          <p:nvCxnSpPr>
            <p:cNvPr id="28" name="Straight Connector 27"/>
            <p:cNvCxnSpPr/>
            <p:nvPr/>
          </p:nvCxnSpPr>
          <p:spPr>
            <a:xfrm flipV="1">
              <a:off x="927761" y="3395694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" name="Picture 5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88" t="32962" r="22391" b="27033"/>
            <a:stretch/>
          </p:blipFill>
          <p:spPr>
            <a:xfrm>
              <a:off x="1050387" y="3144786"/>
              <a:ext cx="2663828" cy="1181528"/>
            </a:xfrm>
            <a:prstGeom prst="rect">
              <a:avLst/>
            </a:prstGeom>
            <a:ln w="9525">
              <a:noFill/>
            </a:ln>
          </p:spPr>
        </p:pic>
        <p:sp>
          <p:nvSpPr>
            <p:cNvPr id="22" name="TextBox 21"/>
            <p:cNvSpPr txBox="1"/>
            <p:nvPr/>
          </p:nvSpPr>
          <p:spPr>
            <a:xfrm>
              <a:off x="3696475" y="3085927"/>
              <a:ext cx="7537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OD</a:t>
              </a:r>
              <a:endPara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02991" y="3251209"/>
              <a:ext cx="34817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249423" y="3021222"/>
            <a:ext cx="4015166" cy="760287"/>
            <a:chOff x="602991" y="4459878"/>
            <a:chExt cx="4015166" cy="760287"/>
          </a:xfrm>
        </p:grpSpPr>
        <p:cxnSp>
          <p:nvCxnSpPr>
            <p:cNvPr id="30" name="Straight Connector 29"/>
            <p:cNvCxnSpPr/>
            <p:nvPr/>
          </p:nvCxnSpPr>
          <p:spPr>
            <a:xfrm flipV="1">
              <a:off x="927761" y="4978310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" name="Picture 4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71" t="38727" r="19244" b="35241"/>
            <a:stretch/>
          </p:blipFill>
          <p:spPr>
            <a:xfrm>
              <a:off x="1050387" y="4459878"/>
              <a:ext cx="2663828" cy="760287"/>
            </a:xfrm>
            <a:prstGeom prst="rect">
              <a:avLst/>
            </a:prstGeom>
            <a:ln w="9525">
              <a:noFill/>
            </a:ln>
          </p:spPr>
        </p:pic>
        <p:sp>
          <p:nvSpPr>
            <p:cNvPr id="23" name="TextBox 22"/>
            <p:cNvSpPr txBox="1"/>
            <p:nvPr/>
          </p:nvSpPr>
          <p:spPr>
            <a:xfrm>
              <a:off x="3665652" y="4877707"/>
              <a:ext cx="9525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ogenin</a:t>
              </a:r>
              <a:endParaRPr lang="en-US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02991" y="4829917"/>
              <a:ext cx="34817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249423" y="4018529"/>
            <a:ext cx="3918277" cy="1089060"/>
            <a:chOff x="602991" y="5457185"/>
            <a:chExt cx="3918277" cy="1089060"/>
          </a:xfrm>
        </p:grpSpPr>
        <p:cxnSp>
          <p:nvCxnSpPr>
            <p:cNvPr id="32" name="Straight Connector 31"/>
            <p:cNvCxnSpPr/>
            <p:nvPr/>
          </p:nvCxnSpPr>
          <p:spPr>
            <a:xfrm flipV="1">
              <a:off x="927761" y="5951169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Picture 7"/>
            <p:cNvPicPr preferRelativeResize="0"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23" t="13384" r="18483" b="55133"/>
            <a:stretch/>
          </p:blipFill>
          <p:spPr>
            <a:xfrm>
              <a:off x="1050387" y="5457185"/>
              <a:ext cx="2661138" cy="1089060"/>
            </a:xfrm>
            <a:prstGeom prst="rect">
              <a:avLst/>
            </a:prstGeom>
            <a:ln w="9525">
              <a:noFill/>
            </a:ln>
          </p:spPr>
        </p:pic>
        <p:sp>
          <p:nvSpPr>
            <p:cNvPr id="24" name="TextBox 23"/>
            <p:cNvSpPr txBox="1"/>
            <p:nvPr/>
          </p:nvSpPr>
          <p:spPr>
            <a:xfrm>
              <a:off x="3688989" y="5745528"/>
              <a:ext cx="8322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en-US" sz="1400" b="1" baseline="30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02991" y="5771516"/>
              <a:ext cx="34817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382632" y="144024"/>
            <a:ext cx="2209707" cy="34406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36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rce data Figure 2H</a:t>
            </a:r>
            <a:endParaRPr lang="en-US" sz="163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437441" y="1218321"/>
            <a:ext cx="562975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x7</a:t>
            </a:r>
            <a:endParaRPr lang="en-US" sz="1400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01" t="25118" r="19826" b="27248"/>
          <a:stretch/>
        </p:blipFill>
        <p:spPr>
          <a:xfrm>
            <a:off x="5956465" y="2533981"/>
            <a:ext cx="1506755" cy="977965"/>
          </a:xfrm>
          <a:prstGeom prst="rect">
            <a:avLst/>
          </a:prstGeom>
          <a:ln>
            <a:noFill/>
          </a:ln>
        </p:spPr>
      </p:pic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18" t="29996" r="24451" b="17751"/>
          <a:stretch/>
        </p:blipFill>
        <p:spPr>
          <a:xfrm>
            <a:off x="5820946" y="1201928"/>
            <a:ext cx="1659365" cy="1008404"/>
          </a:xfrm>
          <a:prstGeom prst="rect">
            <a:avLst/>
          </a:prstGeom>
          <a:ln>
            <a:noFill/>
          </a:ln>
        </p:spPr>
      </p:pic>
      <p:sp>
        <p:nvSpPr>
          <p:cNvPr id="37" name="TextBox 36"/>
          <p:cNvSpPr txBox="1"/>
          <p:nvPr/>
        </p:nvSpPr>
        <p:spPr>
          <a:xfrm>
            <a:off x="7437441" y="2703339"/>
            <a:ext cx="832279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sz="1400" b="1" baseline="30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Straight Connector 37"/>
          <p:cNvCxnSpPr/>
          <p:nvPr/>
        </p:nvCxnSpPr>
        <p:spPr>
          <a:xfrm flipV="1">
            <a:off x="5782011" y="2841830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5413630" y="2709875"/>
            <a:ext cx="348172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Straight Connector 39"/>
          <p:cNvCxnSpPr/>
          <p:nvPr/>
        </p:nvCxnSpPr>
        <p:spPr>
          <a:xfrm flipV="1">
            <a:off x="5782011" y="1373627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5413630" y="1241672"/>
            <a:ext cx="348172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978403" y="257783"/>
            <a:ext cx="2198487" cy="34406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36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rce data Figure 3D</a:t>
            </a:r>
            <a:endParaRPr lang="en-US" sz="163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 flipV="1">
            <a:off x="603392" y="6743228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flipV="1">
            <a:off x="603392" y="7105549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V="1">
            <a:off x="603392" y="8207928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6" name="Picture 45"/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15" t="597" r="14287" b="79743"/>
          <a:stretch/>
        </p:blipFill>
        <p:spPr>
          <a:xfrm>
            <a:off x="809859" y="6326365"/>
            <a:ext cx="2186215" cy="489761"/>
          </a:xfrm>
          <a:prstGeom prst="rect">
            <a:avLst/>
          </a:prstGeom>
          <a:ln w="9525">
            <a:noFill/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60" t="51047" r="8770" b="8661"/>
          <a:stretch/>
        </p:blipFill>
        <p:spPr>
          <a:xfrm>
            <a:off x="755843" y="7011074"/>
            <a:ext cx="2222503" cy="851094"/>
          </a:xfrm>
          <a:prstGeom prst="rect">
            <a:avLst/>
          </a:prstGeom>
          <a:ln w="9525">
            <a:noFill/>
          </a:ln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34" t="51618" r="10420" b="9878"/>
          <a:stretch/>
        </p:blipFill>
        <p:spPr>
          <a:xfrm>
            <a:off x="773880" y="7967775"/>
            <a:ext cx="2145323" cy="815927"/>
          </a:xfrm>
          <a:prstGeom prst="rect">
            <a:avLst/>
          </a:prstGeom>
          <a:ln w="12700">
            <a:noFill/>
          </a:ln>
        </p:spPr>
      </p:pic>
      <p:sp>
        <p:nvSpPr>
          <p:cNvPr id="49" name="TextBox 48"/>
          <p:cNvSpPr txBox="1"/>
          <p:nvPr/>
        </p:nvSpPr>
        <p:spPr>
          <a:xfrm>
            <a:off x="167669" y="6593483"/>
            <a:ext cx="429926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49423" y="6977152"/>
            <a:ext cx="348172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49423" y="8079531"/>
            <a:ext cx="348172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149100" y="6505715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ch1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149100" y="6988217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s6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149100" y="8002794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cxnSp>
        <p:nvCxnSpPr>
          <p:cNvPr id="55" name="Straight Arrow Connector 54"/>
          <p:cNvCxnSpPr/>
          <p:nvPr/>
        </p:nvCxnSpPr>
        <p:spPr>
          <a:xfrm flipH="1">
            <a:off x="2966358" y="6678803"/>
            <a:ext cx="1974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 flipH="1">
            <a:off x="2966358" y="7148126"/>
            <a:ext cx="1974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0" y="5779324"/>
            <a:ext cx="2198487" cy="34406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36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rce data Figure 6D</a:t>
            </a:r>
            <a:endParaRPr lang="en-US" sz="163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72123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0" name="Straight Connector 9"/>
          <p:cNvCxnSpPr/>
          <p:nvPr/>
        </p:nvCxnSpPr>
        <p:spPr>
          <a:xfrm flipV="1">
            <a:off x="532694" y="1029709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V="1">
            <a:off x="532694" y="2090758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532694" y="3291799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V="1">
            <a:off x="532694" y="2888054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532694" y="4296667"/>
            <a:ext cx="182880" cy="14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50" t="9995" r="10199" b="46841"/>
          <a:stretch/>
        </p:blipFill>
        <p:spPr>
          <a:xfrm>
            <a:off x="681978" y="2438912"/>
            <a:ext cx="2222119" cy="1013254"/>
          </a:xfrm>
          <a:prstGeom prst="rect">
            <a:avLst/>
          </a:prstGeom>
          <a:ln w="12700">
            <a:noFill/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3" t="55664" r="7228" b="22800"/>
          <a:stretch/>
        </p:blipFill>
        <p:spPr>
          <a:xfrm>
            <a:off x="712987" y="1763409"/>
            <a:ext cx="2237117" cy="448963"/>
          </a:xfrm>
          <a:prstGeom prst="rect">
            <a:avLst/>
          </a:prstGeom>
          <a:ln w="9525">
            <a:noFill/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35" t="13485" r="10111" b="50522"/>
          <a:stretch/>
        </p:blipFill>
        <p:spPr>
          <a:xfrm>
            <a:off x="673741" y="779982"/>
            <a:ext cx="2236106" cy="773363"/>
          </a:xfrm>
          <a:prstGeom prst="rect">
            <a:avLst/>
          </a:prstGeom>
          <a:ln w="9525">
            <a:noFill/>
          </a:ln>
        </p:spPr>
      </p:pic>
      <p:pic>
        <p:nvPicPr>
          <p:cNvPr id="7" name="Picture 6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0" t="16706" r="7096" b="45304"/>
          <a:stretch/>
        </p:blipFill>
        <p:spPr>
          <a:xfrm>
            <a:off x="677860" y="3617776"/>
            <a:ext cx="2322217" cy="977462"/>
          </a:xfrm>
          <a:prstGeom prst="rect">
            <a:avLst/>
          </a:prstGeom>
          <a:ln w="9525">
            <a:noFill/>
          </a:ln>
        </p:spPr>
      </p:pic>
      <p:sp>
        <p:nvSpPr>
          <p:cNvPr id="11" name="TextBox 10"/>
          <p:cNvSpPr txBox="1"/>
          <p:nvPr/>
        </p:nvSpPr>
        <p:spPr>
          <a:xfrm>
            <a:off x="230988" y="897754"/>
            <a:ext cx="348172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30988" y="1958803"/>
            <a:ext cx="348172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30988" y="3159844"/>
            <a:ext cx="348172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58211" y="2756099"/>
            <a:ext cx="420949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0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30988" y="4164712"/>
            <a:ext cx="348172" cy="288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3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US" sz="1273" b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0" y="127436"/>
            <a:ext cx="2198487" cy="34406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36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rce data Figure 7A</a:t>
            </a:r>
            <a:endParaRPr lang="en-US" sz="163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100811" y="2588791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10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100811" y="306679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52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100811" y="727174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p65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100811" y="1719676"/>
            <a:ext cx="463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65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100811" y="4123635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cxnSp>
        <p:nvCxnSpPr>
          <p:cNvPr id="28" name="Straight Arrow Connector 27"/>
          <p:cNvCxnSpPr/>
          <p:nvPr/>
        </p:nvCxnSpPr>
        <p:spPr>
          <a:xfrm flipH="1">
            <a:off x="2871547" y="895631"/>
            <a:ext cx="1974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H="1">
            <a:off x="2871547" y="1882371"/>
            <a:ext cx="1974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 flipH="1">
            <a:off x="2871547" y="2770752"/>
            <a:ext cx="1974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flipH="1">
            <a:off x="2871547" y="3230926"/>
            <a:ext cx="19742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2" name="Group 31"/>
          <p:cNvGrpSpPr/>
          <p:nvPr/>
        </p:nvGrpSpPr>
        <p:grpSpPr>
          <a:xfrm>
            <a:off x="4381197" y="747877"/>
            <a:ext cx="3239758" cy="3808326"/>
            <a:chOff x="735789" y="3159113"/>
            <a:chExt cx="3239758" cy="3808326"/>
          </a:xfrm>
        </p:grpSpPr>
        <p:cxnSp>
          <p:nvCxnSpPr>
            <p:cNvPr id="33" name="Straight Connector 32"/>
            <p:cNvCxnSpPr/>
            <p:nvPr/>
          </p:nvCxnSpPr>
          <p:spPr>
            <a:xfrm flipV="1">
              <a:off x="1099458" y="5067641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 flipV="1">
              <a:off x="1099458" y="3519784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 flipV="1">
              <a:off x="1099458" y="4244940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V="1">
              <a:off x="1099458" y="6486133"/>
              <a:ext cx="182880" cy="144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/>
            <p:cNvSpPr txBox="1"/>
            <p:nvPr/>
          </p:nvSpPr>
          <p:spPr>
            <a:xfrm>
              <a:off x="808566" y="4935686"/>
              <a:ext cx="34817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35789" y="3387829"/>
              <a:ext cx="420949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9" name="Picture 38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98" t="51487" r="18369" b="14738"/>
            <a:stretch/>
          </p:blipFill>
          <p:spPr>
            <a:xfrm>
              <a:off x="1261216" y="3853809"/>
              <a:ext cx="1898725" cy="726141"/>
            </a:xfrm>
            <a:prstGeom prst="rect">
              <a:avLst/>
            </a:prstGeom>
            <a:ln w="9525">
              <a:solidFill>
                <a:schemeClr val="bg1"/>
              </a:solidFill>
            </a:ln>
          </p:spPr>
        </p:pic>
        <p:pic>
          <p:nvPicPr>
            <p:cNvPr id="40" name="Picture 39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41" t="61869" r="18147" b="2756"/>
            <a:stretch/>
          </p:blipFill>
          <p:spPr>
            <a:xfrm>
              <a:off x="1261216" y="6274102"/>
              <a:ext cx="1949380" cy="693337"/>
            </a:xfrm>
            <a:prstGeom prst="rect">
              <a:avLst/>
            </a:prstGeom>
            <a:ln w="9525">
              <a:solidFill>
                <a:schemeClr val="bg1"/>
              </a:solidFill>
            </a:ln>
          </p:spPr>
        </p:pic>
        <p:pic>
          <p:nvPicPr>
            <p:cNvPr id="41" name="Picture 40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24" t="29200" r="15640" b="54702"/>
            <a:stretch/>
          </p:blipFill>
          <p:spPr>
            <a:xfrm>
              <a:off x="1261216" y="3159113"/>
              <a:ext cx="1879042" cy="432079"/>
            </a:xfrm>
            <a:prstGeom prst="rect">
              <a:avLst/>
            </a:prstGeom>
            <a:ln w="9525">
              <a:solidFill>
                <a:schemeClr val="bg1"/>
              </a:solidFill>
            </a:ln>
          </p:spPr>
        </p:pic>
        <p:pic>
          <p:nvPicPr>
            <p:cNvPr id="42" name="Picture 41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674" t="47835" r="15959" b="10484"/>
            <a:stretch/>
          </p:blipFill>
          <p:spPr>
            <a:xfrm>
              <a:off x="1261216" y="4714422"/>
              <a:ext cx="1907828" cy="1323191"/>
            </a:xfrm>
            <a:prstGeom prst="rect">
              <a:avLst/>
            </a:prstGeom>
            <a:ln w="9525">
              <a:solidFill>
                <a:schemeClr val="bg1"/>
              </a:solidFill>
            </a:ln>
          </p:spPr>
        </p:pic>
        <p:sp>
          <p:nvSpPr>
            <p:cNvPr id="43" name="Rectangle 42"/>
            <p:cNvSpPr/>
            <p:nvPr/>
          </p:nvSpPr>
          <p:spPr>
            <a:xfrm>
              <a:off x="1516209" y="3329936"/>
              <a:ext cx="1371600" cy="211015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1507835" y="4185721"/>
              <a:ext cx="1371600" cy="211015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Rectangle 44"/>
            <p:cNvSpPr/>
            <p:nvPr/>
          </p:nvSpPr>
          <p:spPr>
            <a:xfrm>
              <a:off x="1534631" y="4745080"/>
              <a:ext cx="1371600" cy="211015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Rectangle 45"/>
            <p:cNvSpPr/>
            <p:nvPr/>
          </p:nvSpPr>
          <p:spPr>
            <a:xfrm>
              <a:off x="1556402" y="6434878"/>
              <a:ext cx="1371600" cy="211015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143268" y="6327633"/>
              <a:ext cx="83227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143268" y="3262563"/>
              <a:ext cx="7537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-IRE1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143268" y="4115106"/>
              <a:ext cx="5950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RE1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143268" y="4691319"/>
              <a:ext cx="7040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XBP1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735789" y="4112985"/>
              <a:ext cx="420949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0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08566" y="6354178"/>
              <a:ext cx="348172" cy="288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73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  <a:endParaRPr lang="en-US" sz="1273" b="1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4204945" y="72590"/>
            <a:ext cx="2198487" cy="34406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636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rce data Figure 8A</a:t>
            </a:r>
            <a:endParaRPr lang="en-US" sz="163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54316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4</TotalTime>
  <Words>91</Words>
  <Application>Microsoft Office PowerPoint</Application>
  <PresentationFormat>Custom</PresentationFormat>
  <Paragraphs>65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University of Houst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y, Anirban</dc:creator>
  <cp:lastModifiedBy>Kumar, Ashok</cp:lastModifiedBy>
  <cp:revision>15</cp:revision>
  <dcterms:created xsi:type="dcterms:W3CDTF">2021-08-23T17:50:22Z</dcterms:created>
  <dcterms:modified xsi:type="dcterms:W3CDTF">2021-08-24T22:22:47Z</dcterms:modified>
</cp:coreProperties>
</file>